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88" autoAdjust="0"/>
    <p:restoredTop sz="94660"/>
  </p:normalViewPr>
  <p:slideViewPr>
    <p:cSldViewPr snapToGrid="0">
      <p:cViewPr varScale="1">
        <p:scale>
          <a:sx n="99" d="100"/>
          <a:sy n="99" d="100"/>
        </p:scale>
        <p:origin x="108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C5C9-684D-45AF-A68E-13CD6981FD7F}" type="datetimeFigureOut">
              <a:rPr lang="fr-FR" smtClean="0"/>
              <a:t>12/05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290F-2A33-4A13-95F9-D260691B57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4670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C5C9-684D-45AF-A68E-13CD6981FD7F}" type="datetimeFigureOut">
              <a:rPr lang="fr-FR" smtClean="0"/>
              <a:t>12/05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290F-2A33-4A13-95F9-D260691B57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79831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C5C9-684D-45AF-A68E-13CD6981FD7F}" type="datetimeFigureOut">
              <a:rPr lang="fr-FR" smtClean="0"/>
              <a:t>12/05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290F-2A33-4A13-95F9-D260691B57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9015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C5C9-684D-45AF-A68E-13CD6981FD7F}" type="datetimeFigureOut">
              <a:rPr lang="fr-FR" smtClean="0"/>
              <a:t>12/05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290F-2A33-4A13-95F9-D260691B57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9321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C5C9-684D-45AF-A68E-13CD6981FD7F}" type="datetimeFigureOut">
              <a:rPr lang="fr-FR" smtClean="0"/>
              <a:t>12/05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290F-2A33-4A13-95F9-D260691B57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2253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C5C9-684D-45AF-A68E-13CD6981FD7F}" type="datetimeFigureOut">
              <a:rPr lang="fr-FR" smtClean="0"/>
              <a:t>12/05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290F-2A33-4A13-95F9-D260691B57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9395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C5C9-684D-45AF-A68E-13CD6981FD7F}" type="datetimeFigureOut">
              <a:rPr lang="fr-FR" smtClean="0"/>
              <a:t>12/05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290F-2A33-4A13-95F9-D260691B57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6019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C5C9-684D-45AF-A68E-13CD6981FD7F}" type="datetimeFigureOut">
              <a:rPr lang="fr-FR" smtClean="0"/>
              <a:t>12/05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290F-2A33-4A13-95F9-D260691B57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81157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C5C9-684D-45AF-A68E-13CD6981FD7F}" type="datetimeFigureOut">
              <a:rPr lang="fr-FR" smtClean="0"/>
              <a:t>12/05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290F-2A33-4A13-95F9-D260691B57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7711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C5C9-684D-45AF-A68E-13CD6981FD7F}" type="datetimeFigureOut">
              <a:rPr lang="fr-FR" smtClean="0"/>
              <a:t>12/05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290F-2A33-4A13-95F9-D260691B57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096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8C5C9-684D-45AF-A68E-13CD6981FD7F}" type="datetimeFigureOut">
              <a:rPr lang="fr-FR" smtClean="0"/>
              <a:t>12/05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5290F-2A33-4A13-95F9-D260691B57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1019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B8C5C9-684D-45AF-A68E-13CD6981FD7F}" type="datetimeFigureOut">
              <a:rPr lang="fr-FR" smtClean="0"/>
              <a:t>12/05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B5290F-2A33-4A13-95F9-D260691B57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96830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microsoft.com/office/2007/relationships/hdphoto" Target="../media/hdphoto1.wdp"/><Relationship Id="rId7" Type="http://schemas.openxmlformats.org/officeDocument/2006/relationships/image" Target="../media/image5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openxmlformats.org/officeDocument/2006/relationships/image" Target="../media/image8.tiff"/><Relationship Id="rId7" Type="http://schemas.openxmlformats.org/officeDocument/2006/relationships/image" Target="../media/image11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tiff"/><Relationship Id="rId5" Type="http://schemas.microsoft.com/office/2007/relationships/hdphoto" Target="../media/hdphoto2.wdp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99103" y="0"/>
            <a:ext cx="8520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Summary_GFP_POI8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859942" y="2717563"/>
            <a:ext cx="145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Cut12_10X_1</a:t>
            </a:r>
            <a:endParaRPr lang="fr-FR" sz="1200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88" y="373508"/>
            <a:ext cx="2921576" cy="2344055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0842" y="369332"/>
            <a:ext cx="2926781" cy="2348231"/>
          </a:xfrm>
          <a:prstGeom prst="rect">
            <a:avLst/>
          </a:prstGeom>
        </p:spPr>
      </p:pic>
      <p:sp>
        <p:nvSpPr>
          <p:cNvPr id="17" name="ZoneTexte 16"/>
          <p:cNvSpPr txBox="1"/>
          <p:nvPr/>
        </p:nvSpPr>
        <p:spPr>
          <a:xfrm>
            <a:off x="4022912" y="2713799"/>
            <a:ext cx="145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Cut12_10X_2</a:t>
            </a:r>
            <a:endParaRPr lang="fr-FR" sz="1200" dirty="0"/>
          </a:p>
        </p:txBody>
      </p:sp>
      <p:pic>
        <p:nvPicPr>
          <p:cNvPr id="18" name="Image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0005" y="369333"/>
            <a:ext cx="2922799" cy="2345036"/>
          </a:xfrm>
          <a:prstGeom prst="rect">
            <a:avLst/>
          </a:prstGeom>
        </p:spPr>
      </p:pic>
      <p:sp>
        <p:nvSpPr>
          <p:cNvPr id="19" name="ZoneTexte 18"/>
          <p:cNvSpPr txBox="1"/>
          <p:nvPr/>
        </p:nvSpPr>
        <p:spPr>
          <a:xfrm>
            <a:off x="7138689" y="2718509"/>
            <a:ext cx="145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>
                <a:solidFill>
                  <a:srgbClr val="FF0000"/>
                </a:solidFill>
              </a:rPr>
              <a:t>Cut13_10X_1</a:t>
            </a:r>
            <a:endParaRPr lang="fr-FR" sz="1200" dirty="0">
              <a:solidFill>
                <a:srgbClr val="FF0000"/>
              </a:solidFill>
            </a:endParaRPr>
          </a:p>
        </p:txBody>
      </p:sp>
      <p:pic>
        <p:nvPicPr>
          <p:cNvPr id="20" name="Image 1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13" y="3481220"/>
            <a:ext cx="2919751" cy="2342591"/>
          </a:xfrm>
          <a:prstGeom prst="rect">
            <a:avLst/>
          </a:prstGeom>
        </p:spPr>
      </p:pic>
      <p:sp>
        <p:nvSpPr>
          <p:cNvPr id="21" name="ZoneTexte 20"/>
          <p:cNvSpPr txBox="1"/>
          <p:nvPr/>
        </p:nvSpPr>
        <p:spPr>
          <a:xfrm>
            <a:off x="859942" y="5829451"/>
            <a:ext cx="145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Cut13_10X_2</a:t>
            </a:r>
            <a:endParaRPr lang="fr-FR" sz="1200" dirty="0"/>
          </a:p>
        </p:txBody>
      </p:sp>
      <p:pic>
        <p:nvPicPr>
          <p:cNvPr id="23" name="Image 2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0842" y="3475580"/>
            <a:ext cx="2926781" cy="2348231"/>
          </a:xfrm>
          <a:prstGeom prst="rect">
            <a:avLst/>
          </a:prstGeom>
        </p:spPr>
      </p:pic>
      <p:sp>
        <p:nvSpPr>
          <p:cNvPr id="24" name="ZoneTexte 23"/>
          <p:cNvSpPr txBox="1"/>
          <p:nvPr/>
        </p:nvSpPr>
        <p:spPr>
          <a:xfrm>
            <a:off x="4113930" y="5823811"/>
            <a:ext cx="145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Cut13_10X_3</a:t>
            </a:r>
            <a:endParaRPr lang="fr-FR" sz="1200" dirty="0"/>
          </a:p>
        </p:txBody>
      </p:sp>
      <p:pic>
        <p:nvPicPr>
          <p:cNvPr id="25" name="Image 2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0004" y="3480290"/>
            <a:ext cx="2922799" cy="2345037"/>
          </a:xfrm>
          <a:prstGeom prst="rect">
            <a:avLst/>
          </a:prstGeom>
        </p:spPr>
      </p:pic>
      <p:sp>
        <p:nvSpPr>
          <p:cNvPr id="26" name="ZoneTexte 25"/>
          <p:cNvSpPr txBox="1"/>
          <p:nvPr/>
        </p:nvSpPr>
        <p:spPr>
          <a:xfrm>
            <a:off x="7053703" y="5823810"/>
            <a:ext cx="145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Cut14_10X_1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8050594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99103" y="0"/>
            <a:ext cx="8520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Summary_GFP_POI8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859942" y="2742610"/>
            <a:ext cx="145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Cut14_10X_2.1</a:t>
            </a:r>
            <a:endParaRPr lang="fr-FR" sz="1200" dirty="0"/>
          </a:p>
        </p:txBody>
      </p:sp>
      <p:sp>
        <p:nvSpPr>
          <p:cNvPr id="19" name="ZoneTexte 18"/>
          <p:cNvSpPr txBox="1"/>
          <p:nvPr/>
        </p:nvSpPr>
        <p:spPr>
          <a:xfrm>
            <a:off x="7138689" y="2718509"/>
            <a:ext cx="145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Cut14_10X_3</a:t>
            </a:r>
            <a:endParaRPr lang="fr-FR" sz="1200" dirty="0"/>
          </a:p>
        </p:txBody>
      </p:sp>
      <p:sp>
        <p:nvSpPr>
          <p:cNvPr id="21" name="ZoneTexte 20"/>
          <p:cNvSpPr txBox="1"/>
          <p:nvPr/>
        </p:nvSpPr>
        <p:spPr>
          <a:xfrm>
            <a:off x="859942" y="5829451"/>
            <a:ext cx="145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Cut15_10X_1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113930" y="5823811"/>
            <a:ext cx="145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Cut15_10X_2</a:t>
            </a:r>
            <a:endParaRPr lang="fr-FR" sz="1200" dirty="0"/>
          </a:p>
        </p:txBody>
      </p:sp>
      <p:sp>
        <p:nvSpPr>
          <p:cNvPr id="26" name="ZoneTexte 25"/>
          <p:cNvSpPr txBox="1"/>
          <p:nvPr/>
        </p:nvSpPr>
        <p:spPr>
          <a:xfrm>
            <a:off x="7053703" y="5823810"/>
            <a:ext cx="145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Cut15_10X_3</a:t>
            </a:r>
            <a:endParaRPr lang="fr-FR" sz="1200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35" y="382518"/>
            <a:ext cx="2934292" cy="2354258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0842" y="388545"/>
            <a:ext cx="2926781" cy="2348231"/>
          </a:xfrm>
          <a:prstGeom prst="rect">
            <a:avLst/>
          </a:prstGeom>
        </p:spPr>
      </p:pic>
      <p:sp>
        <p:nvSpPr>
          <p:cNvPr id="22" name="ZoneTexte 21"/>
          <p:cNvSpPr txBox="1"/>
          <p:nvPr/>
        </p:nvSpPr>
        <p:spPr>
          <a:xfrm>
            <a:off x="4022471" y="2736776"/>
            <a:ext cx="145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Cut14_10X_2</a:t>
            </a:r>
            <a:endParaRPr lang="fr-FR" sz="1200" dirty="0"/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8511" y="382518"/>
            <a:ext cx="2934292" cy="2354258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35" y="3475581"/>
            <a:ext cx="2934292" cy="2354258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0842" y="3475581"/>
            <a:ext cx="2926781" cy="2348231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6025" y="3475581"/>
            <a:ext cx="2926778" cy="23482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22423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99103" y="0"/>
            <a:ext cx="8520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Summary_GFP_POI8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859942" y="2742610"/>
            <a:ext cx="145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Cut14_10X_2.1</a:t>
            </a:r>
            <a:endParaRPr lang="fr-FR" sz="1200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35" y="382518"/>
            <a:ext cx="2934292" cy="23542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985666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1</TotalTime>
  <Words>16</Words>
  <Application>Microsoft Office PowerPoint</Application>
  <PresentationFormat>Affichage à l'écran (4:3)</PresentationFormat>
  <Paragraphs>16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kaël POIDEVIN</dc:creator>
  <cp:lastModifiedBy>Mickaël POIDEVIN</cp:lastModifiedBy>
  <cp:revision>29</cp:revision>
  <dcterms:created xsi:type="dcterms:W3CDTF">2023-04-03T07:24:09Z</dcterms:created>
  <dcterms:modified xsi:type="dcterms:W3CDTF">2023-05-12T08:19:23Z</dcterms:modified>
</cp:coreProperties>
</file>